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54" d="100"/>
          <a:sy n="154" d="100"/>
        </p:scale>
        <p:origin x="534" y="1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B25B12-F8B6-7A67-25ED-A010913BA12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480EDD7A-974A-D6E1-7A48-4EEE5D964FD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D3DC3C5-3EFC-7AD3-0B7F-49BAA86FFB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4752-D6C6-43DB-8449-8CA6AD170A7B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058C886-4482-EEA3-CC42-6AF7A73ED8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88703CB-F809-4A4D-8999-8070C647D2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B5C8A-0B60-48E2-87C1-D4B97ED60C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89464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12E31A8-4A69-51A4-BFA5-87E98A8E47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F023FEF-F84E-4F72-1095-464041321F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6388181-0684-72FA-205A-EB9CAB926E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4752-D6C6-43DB-8449-8CA6AD170A7B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3235776-CF30-A1C0-9738-8705FCEDBE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85EBD55-7ABD-B349-A347-7954675DCF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B5C8A-0B60-48E2-87C1-D4B97ED60C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82615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D626B70-EEB6-1706-4D73-850FABFD527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8AB947B-80F5-98E7-F46B-584E5148C9B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3D1D58A-BFC6-53C0-6168-84DF4C042F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4752-D6C6-43DB-8449-8CA6AD170A7B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121A9F0-79D2-2B66-586C-19B882B31E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396B7CD-9773-F97C-EB94-CAAAF5348E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B5C8A-0B60-48E2-87C1-D4B97ED60C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8117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B91F6BA-EB2D-3E20-6ACA-FC84CD7FBB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321DE03-D74F-B21E-80FC-DE6054A6C2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9E0EA50-8C77-3A76-C975-3D23E4D0B2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4752-D6C6-43DB-8449-8CA6AD170A7B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F78E1F4-3BE7-5448-B7ED-FA3449DEC8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B42445D-9E8B-8B86-B4B7-5AC1D60D46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B5C8A-0B60-48E2-87C1-D4B97ED60C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16372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380108B-11A3-6328-FE96-D8201E1441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B0E0E3E-080E-7AAA-3497-0A29CBDA19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2AE7211-8C5C-2A3D-89FE-A611A7C091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4752-D6C6-43DB-8449-8CA6AD170A7B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4293EF3-1798-58DC-7685-0EA6AFC014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336B3E9-C51B-BAB9-7715-8BB2FE587B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B5C8A-0B60-48E2-87C1-D4B97ED60C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85210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297C812-68BF-DECD-1C65-B085F4CAA5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FD1FFEA-3D36-D168-81A9-87CEC57D70C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7DE323C-1392-237F-8DC5-66B7F5E3EF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2364A12-5708-233C-39C1-3B9A15A2BC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4752-D6C6-43DB-8449-8CA6AD170A7B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F163150-B932-01D7-916E-18F0207887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8683E1B-45C8-8212-5623-AA42EDB7AB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B5C8A-0B60-48E2-87C1-D4B97ED60C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31093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8A1133E-23D8-C340-AFC8-6A582F7AA1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9134FA4-9958-CB41-2E3C-FCE6FA1A93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D294F38-9B71-03D2-53A9-E1A5F8F053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8D92C7C-757B-5B18-E32C-0C39EAC8B0A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5500F41-C795-D72A-9183-1DEA6B684C3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0475186-4BDE-316A-0A4D-0ACA06CBC2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4752-D6C6-43DB-8449-8CA6AD170A7B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BA509A2-1416-1A69-5241-99AD59A39F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8A38D2C1-4FDC-4067-6450-38166FA919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B5C8A-0B60-48E2-87C1-D4B97ED60C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2618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46A170F-2F24-1597-F787-F2608B7706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3D8C97B-5717-8FC5-9ACE-DC5B639F6D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4752-D6C6-43DB-8449-8CA6AD170A7B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4CCF685A-A42A-5478-7956-CF784690E9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E17789F-A1AF-ABB4-9FB2-A2CF6094BC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B5C8A-0B60-48E2-87C1-D4B97ED60C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0114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DE96085-95BD-81CC-BA85-D3E9E3B59A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4752-D6C6-43DB-8449-8CA6AD170A7B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C4DF112-46F1-E1BC-2816-2D95CF1AE4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C12450E-4679-78C3-D07E-99F604275D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B5C8A-0B60-48E2-87C1-D4B97ED60C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70338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AF14367-70F6-71A8-1FB0-885C7DFF16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7533D4F-EFDE-4B57-36AA-16F1F23BD3A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C1F25F7-71CA-6B15-1ED7-C826D6570C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BC3F6CE-45FE-A748-C89E-7DA7BB16A7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4752-D6C6-43DB-8449-8CA6AD170A7B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8C9BED0-7A77-3C79-9098-B55BFD0D1E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50DAAD9-8F2E-01A0-DF18-5CE1C9102F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B5C8A-0B60-48E2-87C1-D4B97ED60C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30115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6182447-913C-0220-7BC9-400B2AB8DD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7BEF9D9C-0606-0924-2F5D-9F9B09245F4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BA14F55-5481-AF2E-1799-CC55F2F7DC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E76AA37-C6E0-9E1C-5A38-E4CEDD1758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4752-D6C6-43DB-8449-8CA6AD170A7B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F5E7B58-7953-1399-9C9B-B0AE3C2C7A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DAC0423-2416-CBAE-7AF8-F0317DB032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B5C8A-0B60-48E2-87C1-D4B97ED60C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65600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65C2BA3-2AEB-E11C-F294-94F1A40307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A127C1C-3F58-A049-142B-ABE294238F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8CFDEBE-394B-43AC-E000-52FD4AFD5B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944752-D6C6-43DB-8449-8CA6AD170A7B}" type="datetimeFigureOut">
              <a:rPr lang="zh-CN" altLang="en-US" smtClean="0"/>
              <a:t>2023/3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A30726E-55BB-1A30-D658-3545B6F9CA5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6AB6A43-9BCD-A97C-95D6-F6D220DBF8A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AB5C8A-0B60-48E2-87C1-D4B97ED60C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23183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文本框 26">
            <a:extLst>
              <a:ext uri="{FF2B5EF4-FFF2-40B4-BE49-F238E27FC236}">
                <a16:creationId xmlns:a16="http://schemas.microsoft.com/office/drawing/2014/main" id="{67197109-6584-9D6E-CDC2-BA2DC99B562B}"/>
              </a:ext>
            </a:extLst>
          </p:cNvPr>
          <p:cNvSpPr txBox="1"/>
          <p:nvPr/>
        </p:nvSpPr>
        <p:spPr>
          <a:xfrm>
            <a:off x="624527" y="3835000"/>
            <a:ext cx="9311325" cy="25463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.S1 Construction of recombinant FHV WX19 with deletion of the </a:t>
            </a:r>
            <a:r>
              <a:rPr lang="en-US" altLang="zh-CN" sz="18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gI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8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gE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and TK genes.</a:t>
            </a:r>
          </a:p>
          <a:p>
            <a:pPr algn="just">
              <a:lnSpc>
                <a:spcPct val="200000"/>
              </a:lnSpc>
            </a:pPr>
            <a:r>
              <a:rPr lang="en-US" altLang="zh-CN" sz="16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A: presence of </a:t>
            </a:r>
            <a:r>
              <a:rPr lang="en-US" altLang="zh-CN" sz="1600" kern="100" dirty="0" err="1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gI</a:t>
            </a:r>
            <a:r>
              <a:rPr lang="en-US" altLang="zh-CN" sz="16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/E, fragment in the parenteral FHV by PCR (2739 bp), deletion and replacement of the counterpart by </a:t>
            </a:r>
            <a:r>
              <a:rPr lang="en-US" altLang="zh-CN" sz="1600" kern="100" dirty="0" err="1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eGFP</a:t>
            </a:r>
            <a:r>
              <a:rPr lang="en-US" altLang="zh-CN" sz="16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 in the FHV-</a:t>
            </a:r>
            <a:r>
              <a:rPr lang="en-US" altLang="zh-CN" sz="1600" kern="100" dirty="0" err="1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ΔgI</a:t>
            </a:r>
            <a:r>
              <a:rPr lang="en-US" altLang="zh-CN" sz="16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/E- </a:t>
            </a:r>
            <a:r>
              <a:rPr lang="en-US" altLang="zh-CN" sz="1600" kern="100" dirty="0" err="1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eGFP</a:t>
            </a:r>
            <a:r>
              <a:rPr lang="en-US" altLang="zh-CN" sz="16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 and FHV </a:t>
            </a:r>
            <a:r>
              <a:rPr lang="en-US" altLang="zh-CN" sz="1600" kern="100" dirty="0" err="1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ΔgIgE</a:t>
            </a:r>
            <a:r>
              <a:rPr lang="en-US" altLang="zh-CN" sz="16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/TK </a:t>
            </a:r>
            <a:r>
              <a:rPr lang="en-US" altLang="zh-CN" sz="1600" kern="100" dirty="0" err="1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eGFP</a:t>
            </a:r>
            <a:r>
              <a:rPr lang="en-US" altLang="zh-CN" sz="16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–</a:t>
            </a:r>
            <a:r>
              <a:rPr lang="en-US" altLang="zh-CN" sz="1600" kern="100" dirty="0" err="1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mCherry</a:t>
            </a:r>
            <a:r>
              <a:rPr lang="en-US" altLang="zh-CN" sz="16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 (1715 bp).</a:t>
            </a:r>
          </a:p>
          <a:p>
            <a:pPr algn="just">
              <a:lnSpc>
                <a:spcPct val="200000"/>
              </a:lnSpc>
            </a:pPr>
            <a:r>
              <a:rPr lang="en-US" altLang="zh-CN" sz="16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B: presence of TK, fragment in the parenteral FHV by PCR (1032 bp), deletion and replacement of the counterpart by </a:t>
            </a:r>
            <a:r>
              <a:rPr lang="en-US" altLang="zh-CN" sz="1600" kern="100" dirty="0" err="1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eGFP</a:t>
            </a:r>
            <a:r>
              <a:rPr lang="en-US" altLang="zh-CN" sz="16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 in the FHV-ΔTK-</a:t>
            </a:r>
            <a:r>
              <a:rPr lang="en-US" altLang="zh-CN" sz="1600" kern="100" dirty="0" err="1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mCherry</a:t>
            </a:r>
            <a:r>
              <a:rPr lang="en-US" altLang="zh-CN" sz="16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 and FHV </a:t>
            </a:r>
            <a:r>
              <a:rPr lang="en-US" altLang="zh-CN" sz="1600" kern="100" dirty="0" err="1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ΔgIgE</a:t>
            </a:r>
            <a:r>
              <a:rPr lang="en-US" altLang="zh-CN" sz="16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/TK </a:t>
            </a:r>
            <a:r>
              <a:rPr lang="en-US" altLang="zh-CN" sz="1600" kern="100" dirty="0" err="1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eGFP</a:t>
            </a:r>
            <a:r>
              <a:rPr lang="en-US" altLang="zh-CN" sz="16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–</a:t>
            </a:r>
            <a:r>
              <a:rPr lang="en-US" altLang="zh-CN" sz="1600" kern="100" dirty="0" err="1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mCherry</a:t>
            </a:r>
            <a:r>
              <a:rPr lang="en-US" altLang="zh-CN" sz="16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 (1591 bp).</a:t>
            </a:r>
            <a:endParaRPr lang="zh-CN" alt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D7CCCE3F-E119-CE05-7ADC-462F55F932D6}"/>
              </a:ext>
            </a:extLst>
          </p:cNvPr>
          <p:cNvSpPr txBox="1"/>
          <p:nvPr/>
        </p:nvSpPr>
        <p:spPr>
          <a:xfrm>
            <a:off x="2490493" y="1514712"/>
            <a:ext cx="329592" cy="31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46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46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C64B0E2A-5FEF-EC79-2899-5428F166928F}"/>
              </a:ext>
            </a:extLst>
          </p:cNvPr>
          <p:cNvSpPr txBox="1"/>
          <p:nvPr/>
        </p:nvSpPr>
        <p:spPr>
          <a:xfrm>
            <a:off x="5522070" y="1518055"/>
            <a:ext cx="329592" cy="31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46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46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" name="组合 25">
            <a:extLst>
              <a:ext uri="{FF2B5EF4-FFF2-40B4-BE49-F238E27FC236}">
                <a16:creationId xmlns:a16="http://schemas.microsoft.com/office/drawing/2014/main" id="{E0089562-2710-C8F6-102D-D6D04B499F23}"/>
              </a:ext>
            </a:extLst>
          </p:cNvPr>
          <p:cNvGrpSpPr/>
          <p:nvPr/>
        </p:nvGrpSpPr>
        <p:grpSpPr>
          <a:xfrm>
            <a:off x="3295062" y="-211585"/>
            <a:ext cx="2241400" cy="3574297"/>
            <a:chOff x="3295062" y="-211585"/>
            <a:chExt cx="2241400" cy="3574297"/>
          </a:xfrm>
        </p:grpSpPr>
        <p:grpSp>
          <p:nvGrpSpPr>
            <p:cNvPr id="58" name="组合 57">
              <a:extLst>
                <a:ext uri="{FF2B5EF4-FFF2-40B4-BE49-F238E27FC236}">
                  <a16:creationId xmlns:a16="http://schemas.microsoft.com/office/drawing/2014/main" id="{0801E797-0E6E-1353-9884-C187A085DEBE}"/>
                </a:ext>
              </a:extLst>
            </p:cNvPr>
            <p:cNvGrpSpPr/>
            <p:nvPr/>
          </p:nvGrpSpPr>
          <p:grpSpPr>
            <a:xfrm>
              <a:off x="3325663" y="-211585"/>
              <a:ext cx="2210799" cy="3574297"/>
              <a:chOff x="3335089" y="203194"/>
              <a:chExt cx="2210799" cy="3574297"/>
            </a:xfrm>
          </p:grpSpPr>
          <p:grpSp>
            <p:nvGrpSpPr>
              <p:cNvPr id="15" name="组合 14">
                <a:extLst>
                  <a:ext uri="{FF2B5EF4-FFF2-40B4-BE49-F238E27FC236}">
                    <a16:creationId xmlns:a16="http://schemas.microsoft.com/office/drawing/2014/main" id="{48F6F163-7EC7-E903-C735-E511EA83CAF1}"/>
                  </a:ext>
                </a:extLst>
              </p:cNvPr>
              <p:cNvGrpSpPr/>
              <p:nvPr/>
            </p:nvGrpSpPr>
            <p:grpSpPr>
              <a:xfrm>
                <a:off x="3335089" y="203194"/>
                <a:ext cx="2208125" cy="3574297"/>
                <a:chOff x="4183279" y="-60719"/>
                <a:chExt cx="2208125" cy="3574297"/>
              </a:xfrm>
            </p:grpSpPr>
            <p:grpSp>
              <p:nvGrpSpPr>
                <p:cNvPr id="16" name="组合 15">
                  <a:extLst>
                    <a:ext uri="{FF2B5EF4-FFF2-40B4-BE49-F238E27FC236}">
                      <a16:creationId xmlns:a16="http://schemas.microsoft.com/office/drawing/2014/main" id="{B9A58A87-14C0-3A9E-9167-B4EC9DDC93BC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>
                <a:xfrm>
                  <a:off x="4183279" y="-60719"/>
                  <a:ext cx="2208125" cy="3574297"/>
                  <a:chOff x="5806183" y="77156"/>
                  <a:chExt cx="3073898" cy="4975726"/>
                </a:xfrm>
              </p:grpSpPr>
              <p:pic>
                <p:nvPicPr>
                  <p:cNvPr id="18" name="图片 17">
                    <a:extLst>
                      <a:ext uri="{FF2B5EF4-FFF2-40B4-BE49-F238E27FC236}">
                        <a16:creationId xmlns:a16="http://schemas.microsoft.com/office/drawing/2014/main" id="{3E139CD9-8F17-2E75-46E2-72B254AB5C3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>
                    <a:extLst>
                      <a:ext uri="{BEBA8EAE-BF5A-486C-A8C5-ECC9F3942E4B}">
                        <a14:imgProps xmlns:a14="http://schemas.microsoft.com/office/drawing/2010/main">
                          <a14:imgLayer r:embed="rId3">
                            <a14:imgEffect>
                              <a14:brightnessContrast bright="20000" contrast="-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0043" t="40639" r="55506" b="41150"/>
                  <a:stretch/>
                </p:blipFill>
                <p:spPr>
                  <a:xfrm>
                    <a:off x="5806183" y="2944642"/>
                    <a:ext cx="1883792" cy="2108240"/>
                  </a:xfrm>
                  <a:prstGeom prst="rect">
                    <a:avLst/>
                  </a:prstGeom>
                </p:spPr>
              </p:pic>
              <p:grpSp>
                <p:nvGrpSpPr>
                  <p:cNvPr id="19" name="组合 18">
                    <a:extLst>
                      <a:ext uri="{FF2B5EF4-FFF2-40B4-BE49-F238E27FC236}">
                        <a16:creationId xmlns:a16="http://schemas.microsoft.com/office/drawing/2014/main" id="{69C2EC86-04F8-9ED0-D90C-8ACE53F7AE17}"/>
                      </a:ext>
                    </a:extLst>
                  </p:cNvPr>
                  <p:cNvGrpSpPr/>
                  <p:nvPr/>
                </p:nvGrpSpPr>
                <p:grpSpPr>
                  <a:xfrm>
                    <a:off x="6256354" y="1479754"/>
                    <a:ext cx="2623727" cy="2094172"/>
                    <a:chOff x="6175938" y="2968427"/>
                    <a:chExt cx="2623727" cy="2094172"/>
                  </a:xfrm>
                </p:grpSpPr>
                <p:sp>
                  <p:nvSpPr>
                    <p:cNvPr id="21" name="文本框 20">
                      <a:extLst>
                        <a:ext uri="{FF2B5EF4-FFF2-40B4-BE49-F238E27FC236}">
                          <a16:creationId xmlns:a16="http://schemas.microsoft.com/office/drawing/2014/main" id="{8E0741B7-E029-1855-947C-15B997B7402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719027" y="4719838"/>
                      <a:ext cx="1080638" cy="34276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39 bp</a:t>
                      </a:r>
                      <a:endParaRPr lang="zh-CN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grpSp>
                  <p:nvGrpSpPr>
                    <p:cNvPr id="22" name="组合 21">
                      <a:extLst>
                        <a:ext uri="{FF2B5EF4-FFF2-40B4-BE49-F238E27FC236}">
                          <a16:creationId xmlns:a16="http://schemas.microsoft.com/office/drawing/2014/main" id="{2B44D573-510C-A2E2-95D9-A31244D7860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175938" y="2968427"/>
                      <a:ext cx="1368493" cy="1564576"/>
                      <a:chOff x="1783270" y="2829634"/>
                      <a:chExt cx="1368493" cy="1564576"/>
                    </a:xfrm>
                  </p:grpSpPr>
                  <p:sp>
                    <p:nvSpPr>
                      <p:cNvPr id="23" name="文本框 22">
                        <a:extLst>
                          <a:ext uri="{FF2B5EF4-FFF2-40B4-BE49-F238E27FC236}">
                            <a16:creationId xmlns:a16="http://schemas.microsoft.com/office/drawing/2014/main" id="{6DB62AB5-CA21-CE46-152A-FCC1FE2BFBE2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8362956">
                        <a:off x="1668418" y="3733784"/>
                        <a:ext cx="593888" cy="364183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11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NC</a:t>
                        </a:r>
                        <a:endParaRPr lang="zh-CN" altLang="en-US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24" name="文本框 23">
                        <a:extLst>
                          <a:ext uri="{FF2B5EF4-FFF2-40B4-BE49-F238E27FC236}">
                            <a16:creationId xmlns:a16="http://schemas.microsoft.com/office/drawing/2014/main" id="{257E70D3-2300-10CF-13D8-67F6A637595E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8327401">
                        <a:off x="1741121" y="3429832"/>
                        <a:ext cx="1564573" cy="364183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1100" dirty="0">
                            <a:latin typeface="Times New Roman" panose="02020603050405020304" pitchFamily="18" charset="0"/>
                            <a:ea typeface="等线" panose="02010600030101010101" pitchFamily="2" charset="-122"/>
                            <a:cs typeface="Times New Roman" panose="02020603050405020304" pitchFamily="18" charset="0"/>
                          </a:rPr>
                          <a:t>△</a:t>
                        </a:r>
                        <a:r>
                          <a:rPr lang="en-US" altLang="zh-CN" sz="1100" dirty="0" err="1">
                            <a:latin typeface="Times New Roman" panose="02020603050405020304" pitchFamily="18" charset="0"/>
                            <a:ea typeface="等线" panose="02010600030101010101" pitchFamily="2" charset="-122"/>
                            <a:cs typeface="Times New Roman" panose="02020603050405020304" pitchFamily="18" charset="0"/>
                          </a:rPr>
                          <a:t>gIgE</a:t>
                        </a:r>
                        <a:r>
                          <a:rPr lang="en-US" altLang="zh-CN" sz="1100" dirty="0">
                            <a:latin typeface="Times New Roman" panose="02020603050405020304" pitchFamily="18" charset="0"/>
                            <a:ea typeface="等线" panose="02010600030101010101" pitchFamily="2" charset="-122"/>
                            <a:cs typeface="Times New Roman" panose="02020603050405020304" pitchFamily="18" charset="0"/>
                          </a:rPr>
                          <a:t> </a:t>
                        </a:r>
                        <a:r>
                          <a:rPr lang="en-US" altLang="zh-CN" sz="1100" dirty="0" err="1">
                            <a:latin typeface="Times New Roman" panose="02020603050405020304" pitchFamily="18" charset="0"/>
                            <a:ea typeface="等线" panose="02010600030101010101" pitchFamily="2" charset="-122"/>
                            <a:cs typeface="Times New Roman" panose="02020603050405020304" pitchFamily="18" charset="0"/>
                          </a:rPr>
                          <a:t>eGFP</a:t>
                        </a:r>
                        <a:endParaRPr lang="zh-CN" altLang="en-US" sz="1100" dirty="0"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25" name="文本框 24">
                        <a:extLst>
                          <a:ext uri="{FF2B5EF4-FFF2-40B4-BE49-F238E27FC236}">
                            <a16:creationId xmlns:a16="http://schemas.microsoft.com/office/drawing/2014/main" id="{B49CB4DA-DEEC-24EB-3E5A-CC0E1600965D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8327401">
                        <a:off x="2187385" y="3429829"/>
                        <a:ext cx="1564573" cy="364183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1100" dirty="0">
                            <a:latin typeface="Times New Roman" panose="02020603050405020304" pitchFamily="18" charset="0"/>
                            <a:ea typeface="等线" panose="02010600030101010101" pitchFamily="2" charset="-122"/>
                            <a:cs typeface="Times New Roman" panose="02020603050405020304" pitchFamily="18" charset="0"/>
                          </a:rPr>
                          <a:t>FHV WX19</a:t>
                        </a:r>
                        <a:endParaRPr lang="zh-CN" altLang="en-US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</p:grpSp>
              </p:grpSp>
              <p:sp>
                <p:nvSpPr>
                  <p:cNvPr id="20" name="文本框 19">
                    <a:extLst>
                      <a:ext uri="{FF2B5EF4-FFF2-40B4-BE49-F238E27FC236}">
                        <a16:creationId xmlns:a16="http://schemas.microsoft.com/office/drawing/2014/main" id="{E4CF93D1-0887-6DFB-ABC4-3429EF63DF44}"/>
                      </a:ext>
                    </a:extLst>
                  </p:cNvPr>
                  <p:cNvSpPr txBox="1"/>
                  <p:nvPr/>
                </p:nvSpPr>
                <p:spPr>
                  <a:xfrm rot="18485447">
                    <a:off x="6738975" y="1465138"/>
                    <a:ext cx="3140147" cy="364183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△ </a:t>
                    </a:r>
                    <a:r>
                      <a:rPr lang="en-US" altLang="zh-CN" sz="1100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gI</a:t>
                    </a:r>
                    <a:r>
                      <a:rPr lang="en-US" altLang="zh-CN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/</a:t>
                    </a:r>
                    <a:r>
                      <a:rPr lang="en-US" altLang="zh-CN" sz="1100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gE</a:t>
                    </a:r>
                    <a:r>
                      <a:rPr lang="en-US" altLang="zh-CN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TK </a:t>
                    </a:r>
                    <a:r>
                      <a:rPr lang="en-US" altLang="zh-CN" sz="1100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eGFP-mCherry</a:t>
                    </a:r>
                    <a:endParaRPr lang="zh-CN" altLang="en-US" sz="11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cxnSp>
              <p:nvCxnSpPr>
                <p:cNvPr id="17" name="直接箭头连接符 16">
                  <a:extLst>
                    <a:ext uri="{FF2B5EF4-FFF2-40B4-BE49-F238E27FC236}">
                      <a16:creationId xmlns:a16="http://schemas.microsoft.com/office/drawing/2014/main" id="{66CC2360-20AF-FDCB-3D77-733975FF25C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536495" y="2335757"/>
                  <a:ext cx="121119" cy="0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0E4FEEB0-8DF9-98B6-275F-13B30A0BE7DA}"/>
                  </a:ext>
                </a:extLst>
              </p:cNvPr>
              <p:cNvSpPr txBox="1"/>
              <p:nvPr/>
            </p:nvSpPr>
            <p:spPr>
              <a:xfrm>
                <a:off x="4769615" y="2653608"/>
                <a:ext cx="77627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715 bp</a:t>
                </a:r>
                <a:endParaRPr lang="zh-CN" alt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3" name="直接箭头连接符 32">
                <a:extLst>
                  <a:ext uri="{FF2B5EF4-FFF2-40B4-BE49-F238E27FC236}">
                    <a16:creationId xmlns:a16="http://schemas.microsoft.com/office/drawing/2014/main" id="{F06E6B1F-5694-DF6F-63A8-2EF724C7392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699300" y="2780351"/>
                <a:ext cx="121119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B556BAFD-1339-C885-F393-D9AABEC9BFC4}"/>
                </a:ext>
              </a:extLst>
            </p:cNvPr>
            <p:cNvSpPr txBox="1"/>
            <p:nvPr/>
          </p:nvSpPr>
          <p:spPr>
            <a:xfrm>
              <a:off x="3295062" y="1481315"/>
              <a:ext cx="42945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0" name="组合 29">
            <a:extLst>
              <a:ext uri="{FF2B5EF4-FFF2-40B4-BE49-F238E27FC236}">
                <a16:creationId xmlns:a16="http://schemas.microsoft.com/office/drawing/2014/main" id="{63D0B14E-2C68-D5B8-6143-A38175281643}"/>
              </a:ext>
            </a:extLst>
          </p:cNvPr>
          <p:cNvGrpSpPr/>
          <p:nvPr/>
        </p:nvGrpSpPr>
        <p:grpSpPr>
          <a:xfrm>
            <a:off x="6198242" y="-44150"/>
            <a:ext cx="2188532" cy="3406862"/>
            <a:chOff x="6198242" y="-44150"/>
            <a:chExt cx="2188532" cy="3406862"/>
          </a:xfrm>
        </p:grpSpPr>
        <p:grpSp>
          <p:nvGrpSpPr>
            <p:cNvPr id="59" name="组合 58">
              <a:extLst>
                <a:ext uri="{FF2B5EF4-FFF2-40B4-BE49-F238E27FC236}">
                  <a16:creationId xmlns:a16="http://schemas.microsoft.com/office/drawing/2014/main" id="{A93ACC29-E646-9587-FB46-5C37C6371BD8}"/>
                </a:ext>
              </a:extLst>
            </p:cNvPr>
            <p:cNvGrpSpPr/>
            <p:nvPr/>
          </p:nvGrpSpPr>
          <p:grpSpPr>
            <a:xfrm>
              <a:off x="6209681" y="-44150"/>
              <a:ext cx="2177093" cy="3406862"/>
              <a:chOff x="6219107" y="370629"/>
              <a:chExt cx="2177093" cy="3406862"/>
            </a:xfrm>
          </p:grpSpPr>
          <p:grpSp>
            <p:nvGrpSpPr>
              <p:cNvPr id="4" name="组合 3">
                <a:extLst>
                  <a:ext uri="{FF2B5EF4-FFF2-40B4-BE49-F238E27FC236}">
                    <a16:creationId xmlns:a16="http://schemas.microsoft.com/office/drawing/2014/main" id="{04E11350-5D12-7CF5-0CF0-1DE1B82AEDF7}"/>
                  </a:ext>
                </a:extLst>
              </p:cNvPr>
              <p:cNvGrpSpPr/>
              <p:nvPr/>
            </p:nvGrpSpPr>
            <p:grpSpPr>
              <a:xfrm>
                <a:off x="6219107" y="370629"/>
                <a:ext cx="2169444" cy="3406862"/>
                <a:chOff x="1979033" y="76259"/>
                <a:chExt cx="2169444" cy="3406862"/>
              </a:xfrm>
            </p:grpSpPr>
            <p:grpSp>
              <p:nvGrpSpPr>
                <p:cNvPr id="5" name="组合 4">
                  <a:extLst>
                    <a:ext uri="{FF2B5EF4-FFF2-40B4-BE49-F238E27FC236}">
                      <a16:creationId xmlns:a16="http://schemas.microsoft.com/office/drawing/2014/main" id="{39A9277B-95EA-6BFF-EEFC-4A067AD76A37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>
                <a:xfrm>
                  <a:off x="1979033" y="76259"/>
                  <a:ext cx="2169444" cy="3406862"/>
                  <a:chOff x="2900497" y="106484"/>
                  <a:chExt cx="3000138" cy="4667994"/>
                </a:xfrm>
              </p:grpSpPr>
              <p:grpSp>
                <p:nvGrpSpPr>
                  <p:cNvPr id="7" name="组合 6">
                    <a:extLst>
                      <a:ext uri="{FF2B5EF4-FFF2-40B4-BE49-F238E27FC236}">
                        <a16:creationId xmlns:a16="http://schemas.microsoft.com/office/drawing/2014/main" id="{00C495F5-E5E6-53F0-0198-FBD9F1BDE819}"/>
                      </a:ext>
                    </a:extLst>
                  </p:cNvPr>
                  <p:cNvGrpSpPr/>
                  <p:nvPr/>
                </p:nvGrpSpPr>
                <p:grpSpPr>
                  <a:xfrm>
                    <a:off x="2900497" y="969954"/>
                    <a:ext cx="3000138" cy="3804524"/>
                    <a:chOff x="2862854" y="1006056"/>
                    <a:chExt cx="3000138" cy="3804524"/>
                  </a:xfrm>
                </p:grpSpPr>
                <p:pic>
                  <p:nvPicPr>
                    <p:cNvPr id="9" name="图片 8">
                      <a:extLst>
                        <a:ext uri="{FF2B5EF4-FFF2-40B4-BE49-F238E27FC236}">
                          <a16:creationId xmlns:a16="http://schemas.microsoft.com/office/drawing/2014/main" id="{6C7290D7-EA20-6F97-592C-D8D50E98E30A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4">
                      <a:extLst>
                        <a:ext uri="{BEBA8EAE-BF5A-486C-A8C5-ECC9F3942E4B}">
                          <a14:imgProps xmlns:a14="http://schemas.microsoft.com/office/drawing/2010/main">
                            <a14:imgLayer r:embed="rId5">
                              <a14:imgEffect>
                                <a14:brightnessContrast bright="40000" contrast="-20000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36601" t="40888" r="49012" b="39141"/>
                    <a:stretch/>
                  </p:blipFill>
                  <p:spPr>
                    <a:xfrm>
                      <a:off x="2862854" y="2735522"/>
                      <a:ext cx="1871372" cy="2075058"/>
                    </a:xfrm>
                    <a:prstGeom prst="rect">
                      <a:avLst/>
                    </a:prstGeom>
                  </p:spPr>
                </p:pic>
                <p:grpSp>
                  <p:nvGrpSpPr>
                    <p:cNvPr id="10" name="组合 9">
                      <a:extLst>
                        <a:ext uri="{FF2B5EF4-FFF2-40B4-BE49-F238E27FC236}">
                          <a16:creationId xmlns:a16="http://schemas.microsoft.com/office/drawing/2014/main" id="{68D85311-854F-09A5-7FF4-543672A637D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270328" y="1006056"/>
                      <a:ext cx="2592664" cy="2460060"/>
                      <a:chOff x="1781609" y="2950149"/>
                      <a:chExt cx="2592664" cy="2460060"/>
                    </a:xfrm>
                  </p:grpSpPr>
                  <p:sp>
                    <p:nvSpPr>
                      <p:cNvPr id="11" name="文本框 10">
                        <a:extLst>
                          <a:ext uri="{FF2B5EF4-FFF2-40B4-BE49-F238E27FC236}">
                            <a16:creationId xmlns:a16="http://schemas.microsoft.com/office/drawing/2014/main" id="{3ACF2EFC-01E5-D750-EFAC-4BC9B9CF08F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293636" y="5072843"/>
                        <a:ext cx="1080637" cy="3373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10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1591 bp</a:t>
                        </a:r>
                        <a:endParaRPr lang="zh-CN" altLang="en-US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2" name="文本框 11">
                        <a:extLst>
                          <a:ext uri="{FF2B5EF4-FFF2-40B4-BE49-F238E27FC236}">
                            <a16:creationId xmlns:a16="http://schemas.microsoft.com/office/drawing/2014/main" id="{8C67319C-ECA9-FC76-9B52-2AAA8D4B4A73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8044015">
                        <a:off x="1668289" y="4084174"/>
                        <a:ext cx="588421" cy="36178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11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NC</a:t>
                        </a:r>
                        <a:endParaRPr lang="zh-CN" altLang="en-US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3" name="文本框 12">
                        <a:extLst>
                          <a:ext uri="{FF2B5EF4-FFF2-40B4-BE49-F238E27FC236}">
                            <a16:creationId xmlns:a16="http://schemas.microsoft.com/office/drawing/2014/main" id="{F4F999B6-6E20-ECE0-89D4-9D0764C4B995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8327401">
                        <a:off x="1753049" y="3697109"/>
                        <a:ext cx="1855701" cy="36178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1100" dirty="0">
                            <a:latin typeface="等线" panose="02010600030101010101" pitchFamily="2" charset="-122"/>
                            <a:ea typeface="等线" panose="02010600030101010101" pitchFamily="2" charset="-122"/>
                            <a:cs typeface="Times New Roman" panose="02020603050405020304" pitchFamily="18" charset="0"/>
                          </a:rPr>
                          <a:t>△</a:t>
                        </a:r>
                        <a:r>
                          <a:rPr lang="en-US" altLang="zh-CN" sz="11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TK </a:t>
                        </a:r>
                        <a:r>
                          <a:rPr lang="en-US" altLang="zh-CN" sz="1100" dirty="0" err="1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mCherry</a:t>
                        </a:r>
                        <a:endParaRPr lang="zh-CN" altLang="en-US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4" name="文本框 13">
                        <a:extLst>
                          <a:ext uri="{FF2B5EF4-FFF2-40B4-BE49-F238E27FC236}">
                            <a16:creationId xmlns:a16="http://schemas.microsoft.com/office/drawing/2014/main" id="{F6AB9A6F-E90B-C5E7-5BD2-DB4BD35D1219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8327401">
                        <a:off x="2279618" y="3743893"/>
                        <a:ext cx="1564570" cy="36178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1100" dirty="0">
                            <a:latin typeface="Times New Roman" panose="02020603050405020304" pitchFamily="18" charset="0"/>
                            <a:ea typeface="等线" panose="02010600030101010101" pitchFamily="2" charset="-122"/>
                            <a:cs typeface="Times New Roman" panose="02020603050405020304" pitchFamily="18" charset="0"/>
                          </a:rPr>
                          <a:t>FHV WX19</a:t>
                        </a:r>
                        <a:endParaRPr lang="zh-CN" altLang="en-US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</p:grpSp>
              </p:grpSp>
              <p:sp>
                <p:nvSpPr>
                  <p:cNvPr id="8" name="文本框 7">
                    <a:extLst>
                      <a:ext uri="{FF2B5EF4-FFF2-40B4-BE49-F238E27FC236}">
                        <a16:creationId xmlns:a16="http://schemas.microsoft.com/office/drawing/2014/main" id="{FBB5BEEB-4E24-8523-BEE6-2427738F8C1E}"/>
                      </a:ext>
                    </a:extLst>
                  </p:cNvPr>
                  <p:cNvSpPr txBox="1"/>
                  <p:nvPr/>
                </p:nvSpPr>
                <p:spPr>
                  <a:xfrm rot="18485447">
                    <a:off x="3911427" y="1342974"/>
                    <a:ext cx="2834761" cy="361782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△ </a:t>
                    </a:r>
                    <a:r>
                      <a:rPr lang="en-US" altLang="zh-CN" sz="1100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gI</a:t>
                    </a:r>
                    <a:r>
                      <a:rPr lang="en-US" altLang="zh-CN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/</a:t>
                    </a:r>
                    <a:r>
                      <a:rPr lang="en-US" altLang="zh-CN" sz="1100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gE</a:t>
                    </a:r>
                    <a:r>
                      <a:rPr lang="en-US" altLang="zh-CN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TK </a:t>
                    </a:r>
                    <a:r>
                      <a:rPr lang="en-US" altLang="zh-CN" sz="1100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eGFP-mCherry</a:t>
                    </a:r>
                    <a:endParaRPr lang="zh-CN" altLang="en-US" sz="11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cxnSp>
              <p:nvCxnSpPr>
                <p:cNvPr id="6" name="直接箭头连接符 5">
                  <a:extLst>
                    <a:ext uri="{FF2B5EF4-FFF2-40B4-BE49-F238E27FC236}">
                      <a16:creationId xmlns:a16="http://schemas.microsoft.com/office/drawing/2014/main" id="{7992E6C8-8390-05DC-BB77-5AF354FBB5D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323936" y="2388926"/>
                  <a:ext cx="121119" cy="0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941FD4B4-864C-9EBC-29CC-12CE2698AE1C}"/>
                  </a:ext>
                </a:extLst>
              </p:cNvPr>
              <p:cNvSpPr txBox="1"/>
              <p:nvPr/>
            </p:nvSpPr>
            <p:spPr>
              <a:xfrm>
                <a:off x="7619927" y="2757925"/>
                <a:ext cx="77627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32 bp</a:t>
                </a:r>
                <a:endParaRPr lang="zh-CN" alt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5" name="直接箭头连接符 34">
                <a:extLst>
                  <a:ext uri="{FF2B5EF4-FFF2-40B4-BE49-F238E27FC236}">
                    <a16:creationId xmlns:a16="http://schemas.microsoft.com/office/drawing/2014/main" id="{F3702433-B538-F08A-F73C-917EB5AD52A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549612" y="2884668"/>
                <a:ext cx="121119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D6EFE67F-CFC1-E06E-C9B8-CC6C07614334}"/>
                </a:ext>
              </a:extLst>
            </p:cNvPr>
            <p:cNvSpPr txBox="1"/>
            <p:nvPr/>
          </p:nvSpPr>
          <p:spPr>
            <a:xfrm>
              <a:off x="6198242" y="1468545"/>
              <a:ext cx="42945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859050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</TotalTime>
  <Words>137</Words>
  <Application>Microsoft Office PowerPoint</Application>
  <PresentationFormat>宽屏</PresentationFormat>
  <Paragraphs>1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angaoxing</dc:creator>
  <cp:lastModifiedBy>tangaoxing</cp:lastModifiedBy>
  <cp:revision>5</cp:revision>
  <dcterms:created xsi:type="dcterms:W3CDTF">2023-02-28T04:42:26Z</dcterms:created>
  <dcterms:modified xsi:type="dcterms:W3CDTF">2023-03-10T07:02:06Z</dcterms:modified>
</cp:coreProperties>
</file>